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3" d="100"/>
          <a:sy n="63" d="100"/>
        </p:scale>
        <p:origin x="1380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E&#30424;\&#39640;&#26032;&#20013;&#24515;\&#40644;&#26354;&#38665;&#39033;&#30446;-&#26446;&#23159;&#23159;\MS-&#40644;&#26354;&#38665;miRNA\AF-miRNA-MS\2019-3-29%20for%20RNA%20Biology\2019-4-27%20Revision\Table%20Sx%20%20summary%20of%20the%20distinct%20RNA%20fragment%20categories%20in%20each%20librarie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5.7069574152068203E-2"/>
          <c:y val="0.12971051721064827"/>
          <c:w val="0.93001052920710492"/>
          <c:h val="0.73042190465206491"/>
        </c:manualLayout>
      </c:layout>
      <c:barChart>
        <c:barDir val="col"/>
        <c:grouping val="percentStacked"/>
        <c:varyColors val="0"/>
        <c:ser>
          <c:idx val="0"/>
          <c:order val="0"/>
          <c:tx>
            <c:strRef>
              <c:f>Sheet2!$A$2</c:f>
              <c:strCache>
                <c:ptCount val="1"/>
                <c:pt idx="0">
                  <c:v>miRN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2!$B$1:$I$1</c:f>
              <c:strCache>
                <c:ptCount val="8"/>
                <c:pt idx="0">
                  <c:v>TC1</c:v>
                </c:pt>
                <c:pt idx="1">
                  <c:v>TC2</c:v>
                </c:pt>
                <c:pt idx="2">
                  <c:v>TT1</c:v>
                </c:pt>
                <c:pt idx="3">
                  <c:v>TT2</c:v>
                </c:pt>
                <c:pt idx="4">
                  <c:v>GC1</c:v>
                </c:pt>
                <c:pt idx="5">
                  <c:v>GC2</c:v>
                </c:pt>
                <c:pt idx="6">
                  <c:v>GT1</c:v>
                </c:pt>
                <c:pt idx="7">
                  <c:v>GT2</c:v>
                </c:pt>
              </c:strCache>
            </c:strRef>
          </c:cat>
          <c:val>
            <c:numRef>
              <c:f>Sheet2!$B$2:$I$2</c:f>
              <c:numCache>
                <c:formatCode>General</c:formatCode>
                <c:ptCount val="8"/>
                <c:pt idx="0">
                  <c:v>760457</c:v>
                </c:pt>
                <c:pt idx="1">
                  <c:v>1033628</c:v>
                </c:pt>
                <c:pt idx="2">
                  <c:v>534192</c:v>
                </c:pt>
                <c:pt idx="3">
                  <c:v>692898</c:v>
                </c:pt>
                <c:pt idx="4">
                  <c:v>402603</c:v>
                </c:pt>
                <c:pt idx="5">
                  <c:v>406932</c:v>
                </c:pt>
                <c:pt idx="6">
                  <c:v>607661</c:v>
                </c:pt>
                <c:pt idx="7">
                  <c:v>41614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313-4F81-A15B-2D956C8A6D87}"/>
            </c:ext>
          </c:extLst>
        </c:ser>
        <c:ser>
          <c:idx val="1"/>
          <c:order val="1"/>
          <c:tx>
            <c:strRef>
              <c:f>Sheet2!$A$3</c:f>
              <c:strCache>
                <c:ptCount val="1"/>
                <c:pt idx="0">
                  <c:v>rRNA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2!$B$1:$I$1</c:f>
              <c:strCache>
                <c:ptCount val="8"/>
                <c:pt idx="0">
                  <c:v>TC1</c:v>
                </c:pt>
                <c:pt idx="1">
                  <c:v>TC2</c:v>
                </c:pt>
                <c:pt idx="2">
                  <c:v>TT1</c:v>
                </c:pt>
                <c:pt idx="3">
                  <c:v>TT2</c:v>
                </c:pt>
                <c:pt idx="4">
                  <c:v>GC1</c:v>
                </c:pt>
                <c:pt idx="5">
                  <c:v>GC2</c:v>
                </c:pt>
                <c:pt idx="6">
                  <c:v>GT1</c:v>
                </c:pt>
                <c:pt idx="7">
                  <c:v>GT2</c:v>
                </c:pt>
              </c:strCache>
            </c:strRef>
          </c:cat>
          <c:val>
            <c:numRef>
              <c:f>Sheet2!$B$3:$I$3</c:f>
              <c:numCache>
                <c:formatCode>General</c:formatCode>
                <c:ptCount val="8"/>
                <c:pt idx="0">
                  <c:v>204397</c:v>
                </c:pt>
                <c:pt idx="1">
                  <c:v>331156</c:v>
                </c:pt>
                <c:pt idx="2">
                  <c:v>297730</c:v>
                </c:pt>
                <c:pt idx="3">
                  <c:v>164325</c:v>
                </c:pt>
                <c:pt idx="4">
                  <c:v>579648</c:v>
                </c:pt>
                <c:pt idx="5">
                  <c:v>305019</c:v>
                </c:pt>
                <c:pt idx="6">
                  <c:v>293199</c:v>
                </c:pt>
                <c:pt idx="7">
                  <c:v>4067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313-4F81-A15B-2D956C8A6D87}"/>
            </c:ext>
          </c:extLst>
        </c:ser>
        <c:ser>
          <c:idx val="2"/>
          <c:order val="2"/>
          <c:tx>
            <c:strRef>
              <c:f>Sheet2!$A$4</c:f>
              <c:strCache>
                <c:ptCount val="1"/>
                <c:pt idx="0">
                  <c:v>repeat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Sheet2!$B$1:$I$1</c:f>
              <c:strCache>
                <c:ptCount val="8"/>
                <c:pt idx="0">
                  <c:v>TC1</c:v>
                </c:pt>
                <c:pt idx="1">
                  <c:v>TC2</c:v>
                </c:pt>
                <c:pt idx="2">
                  <c:v>TT1</c:v>
                </c:pt>
                <c:pt idx="3">
                  <c:v>TT2</c:v>
                </c:pt>
                <c:pt idx="4">
                  <c:v>GC1</c:v>
                </c:pt>
                <c:pt idx="5">
                  <c:v>GC2</c:v>
                </c:pt>
                <c:pt idx="6">
                  <c:v>GT1</c:v>
                </c:pt>
                <c:pt idx="7">
                  <c:v>GT2</c:v>
                </c:pt>
              </c:strCache>
            </c:strRef>
          </c:cat>
          <c:val>
            <c:numRef>
              <c:f>Sheet2!$B$4:$I$4</c:f>
              <c:numCache>
                <c:formatCode>General</c:formatCode>
                <c:ptCount val="8"/>
                <c:pt idx="0">
                  <c:v>938094</c:v>
                </c:pt>
                <c:pt idx="1">
                  <c:v>974989</c:v>
                </c:pt>
                <c:pt idx="2">
                  <c:v>945833</c:v>
                </c:pt>
                <c:pt idx="3">
                  <c:v>952523</c:v>
                </c:pt>
                <c:pt idx="4">
                  <c:v>1197593</c:v>
                </c:pt>
                <c:pt idx="5">
                  <c:v>1299182</c:v>
                </c:pt>
                <c:pt idx="6">
                  <c:v>1056171</c:v>
                </c:pt>
                <c:pt idx="7">
                  <c:v>11857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313-4F81-A15B-2D956C8A6D87}"/>
            </c:ext>
          </c:extLst>
        </c:ser>
        <c:ser>
          <c:idx val="3"/>
          <c:order val="3"/>
          <c:tx>
            <c:strRef>
              <c:f>Sheet2!$A$5</c:f>
              <c:strCache>
                <c:ptCount val="1"/>
                <c:pt idx="0">
                  <c:v>snRNA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Sheet2!$B$1:$I$1</c:f>
              <c:strCache>
                <c:ptCount val="8"/>
                <c:pt idx="0">
                  <c:v>TC1</c:v>
                </c:pt>
                <c:pt idx="1">
                  <c:v>TC2</c:v>
                </c:pt>
                <c:pt idx="2">
                  <c:v>TT1</c:v>
                </c:pt>
                <c:pt idx="3">
                  <c:v>TT2</c:v>
                </c:pt>
                <c:pt idx="4">
                  <c:v>GC1</c:v>
                </c:pt>
                <c:pt idx="5">
                  <c:v>GC2</c:v>
                </c:pt>
                <c:pt idx="6">
                  <c:v>GT1</c:v>
                </c:pt>
                <c:pt idx="7">
                  <c:v>GT2</c:v>
                </c:pt>
              </c:strCache>
            </c:strRef>
          </c:cat>
          <c:val>
            <c:numRef>
              <c:f>Sheet2!$B$5:$I$5</c:f>
              <c:numCache>
                <c:formatCode>General</c:formatCode>
                <c:ptCount val="8"/>
                <c:pt idx="0">
                  <c:v>2166</c:v>
                </c:pt>
                <c:pt idx="1">
                  <c:v>2571</c:v>
                </c:pt>
                <c:pt idx="2">
                  <c:v>2269</c:v>
                </c:pt>
                <c:pt idx="3">
                  <c:v>2303</c:v>
                </c:pt>
                <c:pt idx="4">
                  <c:v>3267</c:v>
                </c:pt>
                <c:pt idx="5">
                  <c:v>3104</c:v>
                </c:pt>
                <c:pt idx="6">
                  <c:v>3110</c:v>
                </c:pt>
                <c:pt idx="7">
                  <c:v>29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7313-4F81-A15B-2D956C8A6D87}"/>
            </c:ext>
          </c:extLst>
        </c:ser>
        <c:ser>
          <c:idx val="4"/>
          <c:order val="4"/>
          <c:tx>
            <c:strRef>
              <c:f>Sheet2!$A$6</c:f>
              <c:strCache>
                <c:ptCount val="1"/>
                <c:pt idx="0">
                  <c:v>snoRNA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Sheet2!$B$1:$I$1</c:f>
              <c:strCache>
                <c:ptCount val="8"/>
                <c:pt idx="0">
                  <c:v>TC1</c:v>
                </c:pt>
                <c:pt idx="1">
                  <c:v>TC2</c:v>
                </c:pt>
                <c:pt idx="2">
                  <c:v>TT1</c:v>
                </c:pt>
                <c:pt idx="3">
                  <c:v>TT2</c:v>
                </c:pt>
                <c:pt idx="4">
                  <c:v>GC1</c:v>
                </c:pt>
                <c:pt idx="5">
                  <c:v>GC2</c:v>
                </c:pt>
                <c:pt idx="6">
                  <c:v>GT1</c:v>
                </c:pt>
                <c:pt idx="7">
                  <c:v>GT2</c:v>
                </c:pt>
              </c:strCache>
            </c:strRef>
          </c:cat>
          <c:val>
            <c:numRef>
              <c:f>Sheet2!$B$6:$I$6</c:f>
              <c:numCache>
                <c:formatCode>General</c:formatCode>
                <c:ptCount val="8"/>
                <c:pt idx="0">
                  <c:v>1183</c:v>
                </c:pt>
                <c:pt idx="1">
                  <c:v>1306</c:v>
                </c:pt>
                <c:pt idx="2">
                  <c:v>1124</c:v>
                </c:pt>
                <c:pt idx="3">
                  <c:v>1109</c:v>
                </c:pt>
                <c:pt idx="4">
                  <c:v>1647</c:v>
                </c:pt>
                <c:pt idx="5">
                  <c:v>1709</c:v>
                </c:pt>
                <c:pt idx="6">
                  <c:v>1696</c:v>
                </c:pt>
                <c:pt idx="7">
                  <c:v>13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7313-4F81-A15B-2D956C8A6D87}"/>
            </c:ext>
          </c:extLst>
        </c:ser>
        <c:ser>
          <c:idx val="5"/>
          <c:order val="5"/>
          <c:tx>
            <c:strRef>
              <c:f>Sheet2!$A$7</c:f>
              <c:strCache>
                <c:ptCount val="1"/>
                <c:pt idx="0">
                  <c:v>tRNA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Sheet2!$B$1:$I$1</c:f>
              <c:strCache>
                <c:ptCount val="8"/>
                <c:pt idx="0">
                  <c:v>TC1</c:v>
                </c:pt>
                <c:pt idx="1">
                  <c:v>TC2</c:v>
                </c:pt>
                <c:pt idx="2">
                  <c:v>TT1</c:v>
                </c:pt>
                <c:pt idx="3">
                  <c:v>TT2</c:v>
                </c:pt>
                <c:pt idx="4">
                  <c:v>GC1</c:v>
                </c:pt>
                <c:pt idx="5">
                  <c:v>GC2</c:v>
                </c:pt>
                <c:pt idx="6">
                  <c:v>GT1</c:v>
                </c:pt>
                <c:pt idx="7">
                  <c:v>GT2</c:v>
                </c:pt>
              </c:strCache>
            </c:strRef>
          </c:cat>
          <c:val>
            <c:numRef>
              <c:f>Sheet2!$B$7:$I$7</c:f>
              <c:numCache>
                <c:formatCode>General</c:formatCode>
                <c:ptCount val="8"/>
                <c:pt idx="0">
                  <c:v>98050</c:v>
                </c:pt>
                <c:pt idx="1">
                  <c:v>199169</c:v>
                </c:pt>
                <c:pt idx="2">
                  <c:v>143966</c:v>
                </c:pt>
                <c:pt idx="3">
                  <c:v>114501</c:v>
                </c:pt>
                <c:pt idx="4">
                  <c:v>338515</c:v>
                </c:pt>
                <c:pt idx="5">
                  <c:v>223482</c:v>
                </c:pt>
                <c:pt idx="6">
                  <c:v>267826</c:v>
                </c:pt>
                <c:pt idx="7">
                  <c:v>14625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7313-4F81-A15B-2D956C8A6D87}"/>
            </c:ext>
          </c:extLst>
        </c:ser>
        <c:ser>
          <c:idx val="6"/>
          <c:order val="6"/>
          <c:tx>
            <c:strRef>
              <c:f>Sheet2!$A$8</c:f>
              <c:strCache>
                <c:ptCount val="1"/>
                <c:pt idx="0">
                  <c:v>unann</c:v>
                </c:pt>
              </c:strCache>
            </c:strRef>
          </c:tx>
          <c:spPr>
            <a:solidFill>
              <a:schemeClr val="accent1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2!$B$1:$I$1</c:f>
              <c:strCache>
                <c:ptCount val="8"/>
                <c:pt idx="0">
                  <c:v>TC1</c:v>
                </c:pt>
                <c:pt idx="1">
                  <c:v>TC2</c:v>
                </c:pt>
                <c:pt idx="2">
                  <c:v>TT1</c:v>
                </c:pt>
                <c:pt idx="3">
                  <c:v>TT2</c:v>
                </c:pt>
                <c:pt idx="4">
                  <c:v>GC1</c:v>
                </c:pt>
                <c:pt idx="5">
                  <c:v>GC2</c:v>
                </c:pt>
                <c:pt idx="6">
                  <c:v>GT1</c:v>
                </c:pt>
                <c:pt idx="7">
                  <c:v>GT2</c:v>
                </c:pt>
              </c:strCache>
            </c:strRef>
          </c:cat>
          <c:val>
            <c:numRef>
              <c:f>Sheet2!$B$8:$I$8</c:f>
              <c:numCache>
                <c:formatCode>General</c:formatCode>
                <c:ptCount val="8"/>
                <c:pt idx="0">
                  <c:v>11818275</c:v>
                </c:pt>
                <c:pt idx="1">
                  <c:v>11195957</c:v>
                </c:pt>
                <c:pt idx="2">
                  <c:v>11653011</c:v>
                </c:pt>
                <c:pt idx="3">
                  <c:v>11438232</c:v>
                </c:pt>
                <c:pt idx="4">
                  <c:v>11261807</c:v>
                </c:pt>
                <c:pt idx="5">
                  <c:v>12313424</c:v>
                </c:pt>
                <c:pt idx="6">
                  <c:v>11653595</c:v>
                </c:pt>
                <c:pt idx="7">
                  <c:v>1243852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7313-4F81-A15B-2D956C8A6D8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4"/>
        <c:overlap val="100"/>
        <c:axId val="689192248"/>
        <c:axId val="689192568"/>
      </c:barChart>
      <c:catAx>
        <c:axId val="6891922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689192568"/>
        <c:crosses val="autoZero"/>
        <c:auto val="1"/>
        <c:lblAlgn val="ctr"/>
        <c:lblOffset val="100"/>
        <c:noMultiLvlLbl val="0"/>
      </c:catAx>
      <c:valAx>
        <c:axId val="689192568"/>
        <c:scaling>
          <c:orientation val="minMax"/>
        </c:scaling>
        <c:delete val="0"/>
        <c:axPos val="l"/>
        <c:numFmt formatCode="0%" sourceLinked="1"/>
        <c:majorTickMark val="in"/>
        <c:minorTickMark val="none"/>
        <c:tickLblPos val="nextTo"/>
        <c:spPr>
          <a:noFill/>
          <a:ln>
            <a:solidFill>
              <a:schemeClr val="bg2">
                <a:lumMod val="7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68919224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4781658833343506"/>
          <c:y val="3.0355588873627805E-2"/>
          <c:w val="0.75281630857189363"/>
          <c:h val="5.086944441532025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zh-CN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A2038A-1B89-4827-BCD3-0DC457EE999A}" type="datetimeFigureOut">
              <a:rPr lang="zh-CN" altLang="en-US" smtClean="0"/>
              <a:t>2019/5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70E07-9AF8-43B9-9794-08210957E05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090787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A2038A-1B89-4827-BCD3-0DC457EE999A}" type="datetimeFigureOut">
              <a:rPr lang="zh-CN" altLang="en-US" smtClean="0"/>
              <a:t>2019/5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70E07-9AF8-43B9-9794-08210957E05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91859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A2038A-1B89-4827-BCD3-0DC457EE999A}" type="datetimeFigureOut">
              <a:rPr lang="zh-CN" altLang="en-US" smtClean="0"/>
              <a:t>2019/5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70E07-9AF8-43B9-9794-08210957E05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958970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A2038A-1B89-4827-BCD3-0DC457EE999A}" type="datetimeFigureOut">
              <a:rPr lang="zh-CN" altLang="en-US" smtClean="0"/>
              <a:t>2019/5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70E07-9AF8-43B9-9794-08210957E05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184305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A2038A-1B89-4827-BCD3-0DC457EE999A}" type="datetimeFigureOut">
              <a:rPr lang="zh-CN" altLang="en-US" smtClean="0"/>
              <a:t>2019/5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70E07-9AF8-43B9-9794-08210957E05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863901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A2038A-1B89-4827-BCD3-0DC457EE999A}" type="datetimeFigureOut">
              <a:rPr lang="zh-CN" altLang="en-US" smtClean="0"/>
              <a:t>2019/5/1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70E07-9AF8-43B9-9794-08210957E05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298409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A2038A-1B89-4827-BCD3-0DC457EE999A}" type="datetimeFigureOut">
              <a:rPr lang="zh-CN" altLang="en-US" smtClean="0"/>
              <a:t>2019/5/1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70E07-9AF8-43B9-9794-08210957E05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931498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A2038A-1B89-4827-BCD3-0DC457EE999A}" type="datetimeFigureOut">
              <a:rPr lang="zh-CN" altLang="en-US" smtClean="0"/>
              <a:t>2019/5/1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70E07-9AF8-43B9-9794-08210957E05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930344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A2038A-1B89-4827-BCD3-0DC457EE999A}" type="datetimeFigureOut">
              <a:rPr lang="zh-CN" altLang="en-US" smtClean="0"/>
              <a:t>2019/5/1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70E07-9AF8-43B9-9794-08210957E05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965825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A2038A-1B89-4827-BCD3-0DC457EE999A}" type="datetimeFigureOut">
              <a:rPr lang="zh-CN" altLang="en-US" smtClean="0"/>
              <a:t>2019/5/1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70E07-9AF8-43B9-9794-08210957E05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55472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A2038A-1B89-4827-BCD3-0DC457EE999A}" type="datetimeFigureOut">
              <a:rPr lang="zh-CN" altLang="en-US" smtClean="0"/>
              <a:t>2019/5/1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70E07-9AF8-43B9-9794-08210957E05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539250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A2038A-1B89-4827-BCD3-0DC457EE999A}" type="datetimeFigureOut">
              <a:rPr lang="zh-CN" altLang="en-US" smtClean="0"/>
              <a:t>2019/5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F70E07-9AF8-43B9-9794-08210957E05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227208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图表 3">
            <a:extLst>
              <a:ext uri="{FF2B5EF4-FFF2-40B4-BE49-F238E27FC236}">
                <a16:creationId xmlns:a16="http://schemas.microsoft.com/office/drawing/2014/main" id="{0CF4FA1A-A820-4D1E-8359-CA74666258E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99128674"/>
              </p:ext>
            </p:extLst>
          </p:nvPr>
        </p:nvGraphicFramePr>
        <p:xfrm>
          <a:off x="640080" y="1000760"/>
          <a:ext cx="7863840" cy="38150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矩形 4">
            <a:extLst>
              <a:ext uri="{FF2B5EF4-FFF2-40B4-BE49-F238E27FC236}">
                <a16:creationId xmlns:a16="http://schemas.microsoft.com/office/drawing/2014/main" id="{2328ED84-80AD-4EE0-BA16-7E85B86FB981}"/>
              </a:ext>
            </a:extLst>
          </p:cNvPr>
          <p:cNvSpPr/>
          <p:nvPr/>
        </p:nvSpPr>
        <p:spPr>
          <a:xfrm>
            <a:off x="1757680" y="4631174"/>
            <a:ext cx="640080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D</a:t>
            </a:r>
            <a:r>
              <a: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stinct RNA fragment categories in each librar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140661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</TotalTime>
  <Words>11</Words>
  <Application>Microsoft Office PowerPoint</Application>
  <PresentationFormat>全屏显示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hao cz</dc:creator>
  <cp:lastModifiedBy>zhao cz</cp:lastModifiedBy>
  <cp:revision>2</cp:revision>
  <dcterms:created xsi:type="dcterms:W3CDTF">2019-05-07T14:09:56Z</dcterms:created>
  <dcterms:modified xsi:type="dcterms:W3CDTF">2019-05-11T23:25:18Z</dcterms:modified>
</cp:coreProperties>
</file>